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84524" autoAdjust="0"/>
  </p:normalViewPr>
  <p:slideViewPr>
    <p:cSldViewPr snapToGrid="0" snapToObjects="1">
      <p:cViewPr>
        <p:scale>
          <a:sx n="60" d="100"/>
          <a:sy n="60" d="100"/>
        </p:scale>
        <p:origin x="-2226" y="-5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Figures:nt_distr_with_without_mir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Figures:nt_distr_with_without_mirs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Figures:nt_distr_with_without_mirs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Figures:nt_distr_with_without_mirs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Figures:nt_distr_with_without_mirs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Figures:nt_distr_with_without_mirs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castell:Documents:anopheles:nt_distr_with_without_mir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 dirty="0" smtClean="0"/>
              <a:t>Larvae testis</a:t>
            </a:r>
            <a:r>
              <a:rPr lang="en-US" sz="1000" b="0" baseline="0" dirty="0" smtClean="0"/>
              <a:t> fragment</a:t>
            </a:r>
            <a:endParaRPr lang="en-US" sz="1000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29928859651849"/>
          <c:y val="0.20354077135763901"/>
          <c:w val="0.80268728048604299"/>
          <c:h val="0.616737542397244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ale_fragment_larva_rep2!$A$1</c:f>
              <c:strCache>
                <c:ptCount val="1"/>
                <c:pt idx="0">
                  <c:v>with miRs</c:v>
                </c:pt>
              </c:strCache>
            </c:strRef>
          </c:tx>
          <c:spPr>
            <a:solidFill>
              <a:srgbClr val="308D3E"/>
            </a:solidFill>
          </c:spPr>
          <c:invertIfNegative val="0"/>
          <c:cat>
            <c:numRef>
              <c:f>male_fragment_larva_rep2!$D$11:$D$30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male_fragment_larva_rep2!$C$11:$C$30</c:f>
              <c:numCache>
                <c:formatCode>0</c:formatCode>
                <c:ptCount val="20"/>
                <c:pt idx="0">
                  <c:v>16.509699999999999</c:v>
                </c:pt>
                <c:pt idx="1">
                  <c:v>20.6935</c:v>
                </c:pt>
                <c:pt idx="2">
                  <c:v>34.922899999999998</c:v>
                </c:pt>
                <c:pt idx="3">
                  <c:v>46.7592</c:v>
                </c:pt>
                <c:pt idx="4">
                  <c:v>76.350399999999979</c:v>
                </c:pt>
                <c:pt idx="5">
                  <c:v>154.54849999999999</c:v>
                </c:pt>
                <c:pt idx="6">
                  <c:v>145.1165</c:v>
                </c:pt>
                <c:pt idx="7">
                  <c:v>197.6182</c:v>
                </c:pt>
                <c:pt idx="8">
                  <c:v>182.19540000000001</c:v>
                </c:pt>
                <c:pt idx="9">
                  <c:v>317.14789999999999</c:v>
                </c:pt>
                <c:pt idx="10">
                  <c:v>280.92860000000002</c:v>
                </c:pt>
                <c:pt idx="11">
                  <c:v>329.22</c:v>
                </c:pt>
                <c:pt idx="12">
                  <c:v>372.45769999999999</c:v>
                </c:pt>
                <c:pt idx="13">
                  <c:v>200.8621</c:v>
                </c:pt>
                <c:pt idx="14">
                  <c:v>167.33699999999999</c:v>
                </c:pt>
                <c:pt idx="15">
                  <c:v>235.58279999999999</c:v>
                </c:pt>
                <c:pt idx="16">
                  <c:v>201.2183</c:v>
                </c:pt>
                <c:pt idx="17">
                  <c:v>233.31950000000001</c:v>
                </c:pt>
                <c:pt idx="18">
                  <c:v>223.5736</c:v>
                </c:pt>
                <c:pt idx="19">
                  <c:v>144.4496</c:v>
                </c:pt>
              </c:numCache>
            </c:numRef>
          </c:val>
        </c:ser>
        <c:ser>
          <c:idx val="1"/>
          <c:order val="1"/>
          <c:tx>
            <c:strRef>
              <c:f>male_fragment_larva_rep2!$D$1</c:f>
              <c:strCache>
                <c:ptCount val="1"/>
                <c:pt idx="0">
                  <c:v>Without miRs</c:v>
                </c:pt>
              </c:strCache>
            </c:strRef>
          </c:tx>
          <c:invertIfNegative val="0"/>
          <c:cat>
            <c:numRef>
              <c:f>male_fragment_larva_rep2!$D$11:$D$30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male_fragment_larva_rep2!$F$11:$F$30</c:f>
              <c:numCache>
                <c:formatCode>0</c:formatCode>
                <c:ptCount val="20"/>
                <c:pt idx="0">
                  <c:v>16.432099999999981</c:v>
                </c:pt>
                <c:pt idx="1">
                  <c:v>20.48869999999982</c:v>
                </c:pt>
                <c:pt idx="2">
                  <c:v>34.462899999999998</c:v>
                </c:pt>
                <c:pt idx="3">
                  <c:v>44.345399999999998</c:v>
                </c:pt>
                <c:pt idx="4">
                  <c:v>67.372499999999945</c:v>
                </c:pt>
                <c:pt idx="5">
                  <c:v>96.708100000000002</c:v>
                </c:pt>
                <c:pt idx="6">
                  <c:v>107.38800000000001</c:v>
                </c:pt>
                <c:pt idx="7">
                  <c:v>184.0735</c:v>
                </c:pt>
                <c:pt idx="8">
                  <c:v>179.09059999999999</c:v>
                </c:pt>
                <c:pt idx="9">
                  <c:v>316.94369999999992</c:v>
                </c:pt>
                <c:pt idx="10">
                  <c:v>280.90800000000002</c:v>
                </c:pt>
                <c:pt idx="11">
                  <c:v>329.20440000000002</c:v>
                </c:pt>
                <c:pt idx="12">
                  <c:v>372.4468</c:v>
                </c:pt>
                <c:pt idx="13">
                  <c:v>200.85720000000001</c:v>
                </c:pt>
                <c:pt idx="14">
                  <c:v>167.33420000000001</c:v>
                </c:pt>
                <c:pt idx="15">
                  <c:v>235.57990000000001</c:v>
                </c:pt>
                <c:pt idx="16">
                  <c:v>201.2165</c:v>
                </c:pt>
                <c:pt idx="17">
                  <c:v>233.3092</c:v>
                </c:pt>
                <c:pt idx="18">
                  <c:v>223.56890000000001</c:v>
                </c:pt>
                <c:pt idx="19">
                  <c:v>144.4395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30738176"/>
        <c:axId val="230756736"/>
      </c:barChart>
      <c:catAx>
        <c:axId val="2307381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700"/>
                </a:pPr>
                <a:r>
                  <a:rPr lang="en-US" sz="700"/>
                  <a:t>Read size (nt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756736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2307567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Number of</a:t>
                </a:r>
                <a:r>
                  <a:rPr lang="en-US" sz="700" b="0" baseline="0"/>
                  <a:t> reads * 10000</a:t>
                </a:r>
                <a:endParaRPr lang="en-US" sz="700" b="0"/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738176"/>
        <c:crossesAt val="1"/>
        <c:crossBetween val="between"/>
      </c:valAx>
      <c:spPr>
        <a:ln>
          <a:solidFill>
            <a:schemeClr val="tx1">
              <a:lumMod val="50000"/>
              <a:lumOff val="50000"/>
            </a:schemeClr>
          </a:solidFill>
        </a:ln>
      </c:spPr>
    </c:plotArea>
    <c:legend>
      <c:legendPos val="r"/>
      <c:layout>
        <c:manualLayout>
          <c:xMode val="edge"/>
          <c:yMode val="edge"/>
          <c:x val="9.5345984162999303E-2"/>
          <c:y val="0.20924002127136099"/>
          <c:w val="0.283949998811585"/>
          <c:h val="0.114203358132637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Calibri"/>
                <a:cs typeface="Calibri"/>
              </a:defRPr>
            </a:pPr>
            <a:r>
              <a:rPr lang="en-US" sz="1000" dirty="0" smtClean="0">
                <a:latin typeface="Calibri"/>
                <a:cs typeface="Calibri"/>
              </a:rPr>
              <a:t>Larvae ovary fragment</a:t>
            </a:r>
            <a:endParaRPr lang="en-US" sz="1000" dirty="0">
              <a:latin typeface="Calibri"/>
              <a:cs typeface="Calibri"/>
            </a:endParaRPr>
          </a:p>
        </c:rich>
      </c:tx>
      <c:layout>
        <c:manualLayout>
          <c:xMode val="edge"/>
          <c:yMode val="edge"/>
          <c:x val="0.26478565016064098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22833529963807"/>
          <c:y val="0.15627212826328299"/>
          <c:w val="0.83410345364554395"/>
          <c:h val="0.651683934720682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male_larvae_fragment_rep4!$A$1</c:f>
              <c:strCache>
                <c:ptCount val="1"/>
                <c:pt idx="0">
                  <c:v>With miRs</c:v>
                </c:pt>
              </c:strCache>
            </c:strRef>
          </c:tx>
          <c:spPr>
            <a:solidFill>
              <a:srgbClr val="308D3E"/>
            </a:solidFill>
            <a:ln w="25400">
              <a:noFill/>
            </a:ln>
          </c:spPr>
          <c:invertIfNegative val="0"/>
          <c:cat>
            <c:numRef>
              <c:f>Female_larvae_fragment_rep4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Female_larvae_fragment_rep4!$C$11:$C$30</c:f>
              <c:numCache>
                <c:formatCode>0</c:formatCode>
                <c:ptCount val="20"/>
                <c:pt idx="0">
                  <c:v>24.3172</c:v>
                </c:pt>
                <c:pt idx="1">
                  <c:v>22.813199999999991</c:v>
                </c:pt>
                <c:pt idx="2">
                  <c:v>32.263000000000012</c:v>
                </c:pt>
                <c:pt idx="3">
                  <c:v>34.164999999999999</c:v>
                </c:pt>
                <c:pt idx="4">
                  <c:v>40.3658</c:v>
                </c:pt>
                <c:pt idx="5">
                  <c:v>56.271999999999998</c:v>
                </c:pt>
                <c:pt idx="6">
                  <c:v>33.863999999999997</c:v>
                </c:pt>
                <c:pt idx="7">
                  <c:v>36.759600000000013</c:v>
                </c:pt>
                <c:pt idx="8">
                  <c:v>41.27</c:v>
                </c:pt>
                <c:pt idx="9">
                  <c:v>62.610700000000001</c:v>
                </c:pt>
                <c:pt idx="10">
                  <c:v>46.124299999999998</c:v>
                </c:pt>
                <c:pt idx="11">
                  <c:v>40.695900000000002</c:v>
                </c:pt>
                <c:pt idx="12">
                  <c:v>38.35</c:v>
                </c:pt>
                <c:pt idx="13">
                  <c:v>27.7441</c:v>
                </c:pt>
                <c:pt idx="14">
                  <c:v>23.205400000000001</c:v>
                </c:pt>
                <c:pt idx="15">
                  <c:v>69.511700000000005</c:v>
                </c:pt>
                <c:pt idx="16">
                  <c:v>31.268799999999821</c:v>
                </c:pt>
                <c:pt idx="17">
                  <c:v>32.289700000000003</c:v>
                </c:pt>
                <c:pt idx="18">
                  <c:v>34.574800000000003</c:v>
                </c:pt>
                <c:pt idx="19">
                  <c:v>38.471499999999999</c:v>
                </c:pt>
              </c:numCache>
            </c:numRef>
          </c:val>
        </c:ser>
        <c:ser>
          <c:idx val="1"/>
          <c:order val="1"/>
          <c:tx>
            <c:strRef>
              <c:f>Female_larvae_fragment_rep4!$D$1</c:f>
              <c:strCache>
                <c:ptCount val="1"/>
                <c:pt idx="0">
                  <c:v>Without miRs</c:v>
                </c:pt>
              </c:strCache>
            </c:strRef>
          </c:tx>
          <c:spPr>
            <a:solidFill>
              <a:schemeClr val="accent2"/>
            </a:solidFill>
            <a:ln w="25400">
              <a:noFill/>
            </a:ln>
          </c:spPr>
          <c:invertIfNegative val="0"/>
          <c:cat>
            <c:numRef>
              <c:f>Female_larvae_fragment_rep4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Female_larvae_fragment_rep4!$F$11:$F$30</c:f>
              <c:numCache>
                <c:formatCode>0</c:formatCode>
                <c:ptCount val="20"/>
                <c:pt idx="0">
                  <c:v>24.262</c:v>
                </c:pt>
                <c:pt idx="1">
                  <c:v>22.661000000000001</c:v>
                </c:pt>
                <c:pt idx="2">
                  <c:v>31.582100000000001</c:v>
                </c:pt>
                <c:pt idx="3">
                  <c:v>32.627600000000001</c:v>
                </c:pt>
                <c:pt idx="4">
                  <c:v>37.563299999999998</c:v>
                </c:pt>
                <c:pt idx="5">
                  <c:v>40.793800000000012</c:v>
                </c:pt>
                <c:pt idx="6">
                  <c:v>27.6828</c:v>
                </c:pt>
                <c:pt idx="7">
                  <c:v>34.917999999999999</c:v>
                </c:pt>
                <c:pt idx="8">
                  <c:v>40.2286</c:v>
                </c:pt>
                <c:pt idx="9">
                  <c:v>62.573900000000002</c:v>
                </c:pt>
                <c:pt idx="10">
                  <c:v>46.120800000000003</c:v>
                </c:pt>
                <c:pt idx="11">
                  <c:v>40.694899999999997</c:v>
                </c:pt>
                <c:pt idx="12">
                  <c:v>38.3489</c:v>
                </c:pt>
                <c:pt idx="13">
                  <c:v>27.7438</c:v>
                </c:pt>
                <c:pt idx="14">
                  <c:v>23.204999999999991</c:v>
                </c:pt>
                <c:pt idx="15">
                  <c:v>69.511099999999999</c:v>
                </c:pt>
                <c:pt idx="16">
                  <c:v>31.268000000000001</c:v>
                </c:pt>
                <c:pt idx="17">
                  <c:v>32.2879</c:v>
                </c:pt>
                <c:pt idx="18">
                  <c:v>34.574000000000012</c:v>
                </c:pt>
                <c:pt idx="19">
                  <c:v>38.4701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30778368"/>
        <c:axId val="230780288"/>
      </c:barChart>
      <c:catAx>
        <c:axId val="2307783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700">
                    <a:latin typeface="Calibri"/>
                    <a:cs typeface="Calibri"/>
                  </a:defRPr>
                </a:pPr>
                <a:r>
                  <a:rPr lang="en-US" sz="700" dirty="0" smtClean="0">
                    <a:latin typeface="Calibri"/>
                    <a:cs typeface="Calibri"/>
                  </a:rPr>
                  <a:t>Read size</a:t>
                </a:r>
                <a:r>
                  <a:rPr lang="en-US" sz="700" baseline="0" dirty="0" smtClean="0">
                    <a:latin typeface="Calibri"/>
                    <a:cs typeface="Calibri"/>
                  </a:rPr>
                  <a:t> (</a:t>
                </a:r>
                <a:r>
                  <a:rPr lang="en-US" sz="700" baseline="0" dirty="0" err="1" smtClean="0">
                    <a:latin typeface="Calibri"/>
                    <a:cs typeface="Calibri"/>
                  </a:rPr>
                  <a:t>nt</a:t>
                </a:r>
                <a:r>
                  <a:rPr lang="en-US" sz="700" baseline="0" dirty="0" smtClean="0">
                    <a:latin typeface="Calibri"/>
                    <a:cs typeface="Calibri"/>
                  </a:rPr>
                  <a:t>)</a:t>
                </a:r>
                <a:endParaRPr lang="en-US" sz="700" dirty="0">
                  <a:latin typeface="Calibri"/>
                  <a:cs typeface="Calibri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B3B3B3"/>
            </a:solidFill>
            <a:prstDash val="solid"/>
          </a:ln>
        </c:spPr>
        <c:txPr>
          <a:bodyPr rot="0" vert="horz"/>
          <a:lstStyle/>
          <a:p>
            <a:pPr>
              <a:defRPr sz="700" b="0" i="0" u="none" strike="noStrike" baseline="0">
                <a:solidFill>
                  <a:srgbClr val="1F1C1B"/>
                </a:solidFill>
                <a:latin typeface="Calibri"/>
                <a:ea typeface="Arial"/>
                <a:cs typeface="Calibri"/>
              </a:defRPr>
            </a:pPr>
            <a:endParaRPr lang="en-US"/>
          </a:p>
        </c:txPr>
        <c:crossAx val="230780288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2307802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Calibri"/>
                    <a:cs typeface="Calibri"/>
                  </a:defRPr>
                </a:pPr>
                <a:r>
                  <a:rPr lang="en-US" sz="700" dirty="0" smtClean="0">
                    <a:latin typeface="Calibri"/>
                    <a:cs typeface="Calibri"/>
                  </a:rPr>
                  <a:t>Read number * 10000</a:t>
                </a:r>
                <a:endParaRPr lang="en-US" sz="700" dirty="0">
                  <a:latin typeface="Calibri"/>
                  <a:cs typeface="Calibri"/>
                </a:endParaRP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spPr>
          <a:ln w="3175">
            <a:solidFill>
              <a:srgbClr val="B3B3B3"/>
            </a:solidFill>
            <a:prstDash val="solid"/>
          </a:ln>
        </c:spPr>
        <c:txPr>
          <a:bodyPr rot="0" vert="horz"/>
          <a:lstStyle/>
          <a:p>
            <a:pPr>
              <a:defRPr sz="700" b="0" i="0" u="none" strike="noStrike" baseline="0">
                <a:solidFill>
                  <a:srgbClr val="1F1C1B"/>
                </a:solidFill>
                <a:latin typeface="Calibri"/>
                <a:ea typeface="Arial"/>
                <a:cs typeface="Calibri"/>
              </a:defRPr>
            </a:pPr>
            <a:endParaRPr lang="en-US"/>
          </a:p>
        </c:txPr>
        <c:crossAx val="230778368"/>
        <c:crossesAt val="1"/>
        <c:crossBetween val="between"/>
      </c:valAx>
      <c:spPr>
        <a:noFill/>
        <a:ln w="3175">
          <a:solidFill>
            <a:srgbClr val="B3B3B3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11165330597473901"/>
          <c:y val="0.15933742373670801"/>
          <c:w val="0.24731966082280099"/>
          <c:h val="0.128635757625228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700" b="0" i="0" u="none" strike="noStrike" baseline="0">
              <a:solidFill>
                <a:srgbClr val="1F1C1B"/>
              </a:solidFill>
              <a:latin typeface="Calibri"/>
              <a:ea typeface="Arial"/>
              <a:cs typeface="Calibri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b="0"/>
              <a:t>Adult</a:t>
            </a:r>
            <a:r>
              <a:rPr lang="en-US" sz="1000" b="0" baseline="0"/>
              <a:t> testes</a:t>
            </a:r>
            <a:endParaRPr lang="en-US" sz="1000" b="0"/>
          </a:p>
        </c:rich>
      </c:tx>
      <c:layout>
        <c:manualLayout>
          <c:xMode val="edge"/>
          <c:yMode val="edge"/>
          <c:x val="0.40807747185964199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195366639767399"/>
          <c:y val="0.14503572532626399"/>
          <c:w val="0.69954057069951403"/>
          <c:h val="0.621106053931773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dult_testes_rep2!$A$1</c:f>
              <c:strCache>
                <c:ptCount val="1"/>
                <c:pt idx="0">
                  <c:v>With miRs</c:v>
                </c:pt>
              </c:strCache>
            </c:strRef>
          </c:tx>
          <c:spPr>
            <a:solidFill>
              <a:srgbClr val="308D3E"/>
            </a:solidFill>
          </c:spPr>
          <c:invertIfNegative val="0"/>
          <c:cat>
            <c:numRef>
              <c:f>Adult_testes_rep2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Adult_testes_rep2!$C$11:$C$30</c:f>
              <c:numCache>
                <c:formatCode>0</c:formatCode>
                <c:ptCount val="20"/>
                <c:pt idx="0">
                  <c:v>2.4998</c:v>
                </c:pt>
                <c:pt idx="1">
                  <c:v>3.5137999999999998</c:v>
                </c:pt>
                <c:pt idx="2">
                  <c:v>4.9347000000000003</c:v>
                </c:pt>
                <c:pt idx="3">
                  <c:v>9.781600000000001</c:v>
                </c:pt>
                <c:pt idx="4">
                  <c:v>18.925599999999822</c:v>
                </c:pt>
                <c:pt idx="5">
                  <c:v>27.947299999999981</c:v>
                </c:pt>
                <c:pt idx="6">
                  <c:v>21.088799999999821</c:v>
                </c:pt>
                <c:pt idx="7">
                  <c:v>29.450299999999999</c:v>
                </c:pt>
                <c:pt idx="8">
                  <c:v>65.038300000000007</c:v>
                </c:pt>
                <c:pt idx="9">
                  <c:v>116.4768</c:v>
                </c:pt>
                <c:pt idx="10">
                  <c:v>122.50709999999999</c:v>
                </c:pt>
                <c:pt idx="11">
                  <c:v>75.807400000000001</c:v>
                </c:pt>
                <c:pt idx="12">
                  <c:v>43.051000000000002</c:v>
                </c:pt>
                <c:pt idx="13">
                  <c:v>11.8551</c:v>
                </c:pt>
                <c:pt idx="14">
                  <c:v>9.3544</c:v>
                </c:pt>
                <c:pt idx="15">
                  <c:v>20.863299999999999</c:v>
                </c:pt>
                <c:pt idx="16">
                  <c:v>8.6514000000000006</c:v>
                </c:pt>
                <c:pt idx="17">
                  <c:v>3.8822999999999981</c:v>
                </c:pt>
                <c:pt idx="18">
                  <c:v>4.6347999999999967</c:v>
                </c:pt>
                <c:pt idx="19">
                  <c:v>3.8338000000000001</c:v>
                </c:pt>
              </c:numCache>
            </c:numRef>
          </c:val>
        </c:ser>
        <c:ser>
          <c:idx val="1"/>
          <c:order val="1"/>
          <c:tx>
            <c:strRef>
              <c:f>Adult_testes_rep2!$D$1</c:f>
              <c:strCache>
                <c:ptCount val="1"/>
                <c:pt idx="0">
                  <c:v>Without miRs</c:v>
                </c:pt>
              </c:strCache>
            </c:strRef>
          </c:tx>
          <c:invertIfNegative val="0"/>
          <c:cat>
            <c:numRef>
              <c:f>Adult_testes_rep2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Adult_testes_rep2!$F$11:$F$30</c:f>
              <c:numCache>
                <c:formatCode>0</c:formatCode>
                <c:ptCount val="20"/>
                <c:pt idx="0">
                  <c:v>2.4356</c:v>
                </c:pt>
                <c:pt idx="1">
                  <c:v>3.334499999999998</c:v>
                </c:pt>
                <c:pt idx="2">
                  <c:v>4.6260999999999957</c:v>
                </c:pt>
                <c:pt idx="3">
                  <c:v>7.8970999999999947</c:v>
                </c:pt>
                <c:pt idx="4">
                  <c:v>13.7262</c:v>
                </c:pt>
                <c:pt idx="5">
                  <c:v>12.504300000000001</c:v>
                </c:pt>
                <c:pt idx="6">
                  <c:v>16.665299999999981</c:v>
                </c:pt>
                <c:pt idx="7">
                  <c:v>28.801100000000009</c:v>
                </c:pt>
                <c:pt idx="8">
                  <c:v>64.855799999999945</c:v>
                </c:pt>
                <c:pt idx="9">
                  <c:v>116.4619</c:v>
                </c:pt>
                <c:pt idx="10">
                  <c:v>122.492</c:v>
                </c:pt>
                <c:pt idx="11">
                  <c:v>75.798900000000003</c:v>
                </c:pt>
                <c:pt idx="12">
                  <c:v>43.049500000000002</c:v>
                </c:pt>
                <c:pt idx="13">
                  <c:v>11.8543</c:v>
                </c:pt>
                <c:pt idx="14">
                  <c:v>9.3544</c:v>
                </c:pt>
                <c:pt idx="15">
                  <c:v>20.862200000000001</c:v>
                </c:pt>
                <c:pt idx="16">
                  <c:v>8.6513000000000009</c:v>
                </c:pt>
                <c:pt idx="17">
                  <c:v>3.8820999999999981</c:v>
                </c:pt>
                <c:pt idx="18">
                  <c:v>4.6345999999999936</c:v>
                </c:pt>
                <c:pt idx="19">
                  <c:v>3.8334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30802176"/>
        <c:axId val="230804096"/>
      </c:barChart>
      <c:catAx>
        <c:axId val="2308021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700" b="0"/>
                </a:pPr>
                <a:r>
                  <a:rPr lang="en-US" sz="700" b="0"/>
                  <a:t>Read size (nt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804096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2308040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ad number * 10000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802176"/>
        <c:crossesAt val="1"/>
        <c:crossBetween val="between"/>
        <c:majorUnit val="20"/>
      </c:valAx>
      <c:spPr>
        <a:ln>
          <a:solidFill>
            <a:schemeClr val="tx1">
              <a:lumMod val="50000"/>
              <a:lumOff val="50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18127096334786699"/>
          <c:y val="0.14408295360284901"/>
          <c:w val="0.20575490144268899"/>
          <c:h val="0.12158735483616299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/>
              <a:t>Non blood fed ovaries</a:t>
            </a:r>
          </a:p>
        </c:rich>
      </c:tx>
      <c:layout>
        <c:manualLayout>
          <c:xMode val="edge"/>
          <c:yMode val="edge"/>
          <c:x val="0.29025506993719402"/>
          <c:y val="3.846151516564799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621747217673199"/>
          <c:y val="0.16196598306118501"/>
          <c:w val="0.72698247477723099"/>
          <c:h val="0.685257004689882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on_blood_fed_female_ovaries_re!$A$1</c:f>
              <c:strCache>
                <c:ptCount val="1"/>
                <c:pt idx="0">
                  <c:v>with miRs</c:v>
                </c:pt>
              </c:strCache>
            </c:strRef>
          </c:tx>
          <c:spPr>
            <a:solidFill>
              <a:srgbClr val="308D3E"/>
            </a:solidFill>
          </c:spPr>
          <c:invertIfNegative val="0"/>
          <c:cat>
            <c:numRef>
              <c:f>Non_blood_fed_female_ovaries_re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Non_blood_fed_female_ovaries_re!$C$11:$C$30</c:f>
              <c:numCache>
                <c:formatCode>0</c:formatCode>
                <c:ptCount val="20"/>
                <c:pt idx="0">
                  <c:v>1.7112000000000001</c:v>
                </c:pt>
                <c:pt idx="1">
                  <c:v>1.2843</c:v>
                </c:pt>
                <c:pt idx="2">
                  <c:v>1.5570999999999999</c:v>
                </c:pt>
                <c:pt idx="3">
                  <c:v>4.2701000000000002</c:v>
                </c:pt>
                <c:pt idx="4">
                  <c:v>14.192399999999999</c:v>
                </c:pt>
                <c:pt idx="5">
                  <c:v>41.012500000000003</c:v>
                </c:pt>
                <c:pt idx="6">
                  <c:v>21.304500000000001</c:v>
                </c:pt>
                <c:pt idx="7">
                  <c:v>44.427300000000002</c:v>
                </c:pt>
                <c:pt idx="8">
                  <c:v>133.2227</c:v>
                </c:pt>
                <c:pt idx="9">
                  <c:v>240.6551</c:v>
                </c:pt>
                <c:pt idx="10">
                  <c:v>247.44380000000001</c:v>
                </c:pt>
                <c:pt idx="11">
                  <c:v>156.25620000000001</c:v>
                </c:pt>
                <c:pt idx="12">
                  <c:v>66.696799999999982</c:v>
                </c:pt>
                <c:pt idx="13">
                  <c:v>11.405099999999999</c:v>
                </c:pt>
                <c:pt idx="14">
                  <c:v>5.1157999999999966</c:v>
                </c:pt>
                <c:pt idx="15">
                  <c:v>4.1988999999999956</c:v>
                </c:pt>
                <c:pt idx="16">
                  <c:v>2.1919</c:v>
                </c:pt>
                <c:pt idx="17">
                  <c:v>1.7859</c:v>
                </c:pt>
                <c:pt idx="18">
                  <c:v>1.8994</c:v>
                </c:pt>
                <c:pt idx="19">
                  <c:v>1.907</c:v>
                </c:pt>
              </c:numCache>
            </c:numRef>
          </c:val>
        </c:ser>
        <c:ser>
          <c:idx val="1"/>
          <c:order val="1"/>
          <c:tx>
            <c:strRef>
              <c:f>Non_blood_fed_female_ovaries_re!$D$1</c:f>
              <c:strCache>
                <c:ptCount val="1"/>
                <c:pt idx="0">
                  <c:v>Without miRs</c:v>
                </c:pt>
              </c:strCache>
            </c:strRef>
          </c:tx>
          <c:invertIfNegative val="0"/>
          <c:cat>
            <c:numRef>
              <c:f>Non_blood_fed_female_ovaries_re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Non_blood_fed_female_ovaries_re!$F$11:$F$30</c:f>
              <c:numCache>
                <c:formatCode>0</c:formatCode>
                <c:ptCount val="20"/>
                <c:pt idx="0">
                  <c:v>1.6533</c:v>
                </c:pt>
                <c:pt idx="1">
                  <c:v>1.1361000000000001</c:v>
                </c:pt>
                <c:pt idx="2">
                  <c:v>1.2277</c:v>
                </c:pt>
                <c:pt idx="3">
                  <c:v>2.1391</c:v>
                </c:pt>
                <c:pt idx="4">
                  <c:v>5.0164999999999997</c:v>
                </c:pt>
                <c:pt idx="5">
                  <c:v>6.5654999999999966</c:v>
                </c:pt>
                <c:pt idx="6">
                  <c:v>11.676500000000001</c:v>
                </c:pt>
                <c:pt idx="7">
                  <c:v>38.044899999999998</c:v>
                </c:pt>
                <c:pt idx="8">
                  <c:v>131.25550000000001</c:v>
                </c:pt>
                <c:pt idx="9">
                  <c:v>240.51820000000001</c:v>
                </c:pt>
                <c:pt idx="10">
                  <c:v>247.36969999999999</c:v>
                </c:pt>
                <c:pt idx="11">
                  <c:v>156.2133</c:v>
                </c:pt>
                <c:pt idx="12">
                  <c:v>66.691300000000012</c:v>
                </c:pt>
                <c:pt idx="13">
                  <c:v>11.403499999999999</c:v>
                </c:pt>
                <c:pt idx="14">
                  <c:v>5.1149999999999807</c:v>
                </c:pt>
                <c:pt idx="15">
                  <c:v>4.1964999999999986</c:v>
                </c:pt>
                <c:pt idx="16">
                  <c:v>2.1918000000000002</c:v>
                </c:pt>
                <c:pt idx="17">
                  <c:v>1.7851999999999999</c:v>
                </c:pt>
                <c:pt idx="18">
                  <c:v>1.8975</c:v>
                </c:pt>
                <c:pt idx="19">
                  <c:v>1.90579999999999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30842368"/>
        <c:axId val="230844288"/>
      </c:barChart>
      <c:catAx>
        <c:axId val="2308423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700" b="0"/>
                </a:pPr>
                <a:r>
                  <a:rPr lang="en-US" sz="700" b="0"/>
                  <a:t>Read size (nt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844288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2308442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ad number * 10000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842368"/>
        <c:crossesAt val="1"/>
        <c:crossBetween val="between"/>
      </c:valAx>
      <c:spPr>
        <a:ln>
          <a:solidFill>
            <a:schemeClr val="tx1">
              <a:lumMod val="50000"/>
              <a:lumOff val="50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16413466233917801"/>
          <c:y val="0.17718947474895499"/>
          <c:w val="0.21139467564212999"/>
          <c:h val="0.17202291216056201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/>
              <a:t>Blood fed ovaries</a:t>
            </a:r>
          </a:p>
        </c:rich>
      </c:tx>
      <c:layout>
        <c:manualLayout>
          <c:xMode val="edge"/>
          <c:yMode val="edge"/>
          <c:x val="0.35567981202071502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2825200097455799"/>
          <c:y val="0.143012827384143"/>
          <c:w val="0.75624122148549999"/>
          <c:h val="0.662193690456812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Blood_fed_female_ovaries_rep1!$A$1</c:f>
              <c:strCache>
                <c:ptCount val="1"/>
                <c:pt idx="0">
                  <c:v>With miRs</c:v>
                </c:pt>
              </c:strCache>
            </c:strRef>
          </c:tx>
          <c:spPr>
            <a:solidFill>
              <a:srgbClr val="308D3E"/>
            </a:solidFill>
          </c:spPr>
          <c:invertIfNegative val="0"/>
          <c:cat>
            <c:numRef>
              <c:f>Blood_fed_female_ovaries_rep1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Blood_fed_female_ovaries_rep1!$C$11:$C$30</c:f>
              <c:numCache>
                <c:formatCode>0</c:formatCode>
                <c:ptCount val="20"/>
                <c:pt idx="0">
                  <c:v>0.36509999999999998</c:v>
                </c:pt>
                <c:pt idx="1">
                  <c:v>1.6335</c:v>
                </c:pt>
                <c:pt idx="2">
                  <c:v>0.56179999999999997</c:v>
                </c:pt>
                <c:pt idx="3">
                  <c:v>1.1328</c:v>
                </c:pt>
                <c:pt idx="4">
                  <c:v>3.5941999999999998</c:v>
                </c:pt>
                <c:pt idx="5">
                  <c:v>15.2986</c:v>
                </c:pt>
                <c:pt idx="6">
                  <c:v>8.7871000000000006</c:v>
                </c:pt>
                <c:pt idx="7">
                  <c:v>22.534099999999999</c:v>
                </c:pt>
                <c:pt idx="8">
                  <c:v>50.229500000000002</c:v>
                </c:pt>
                <c:pt idx="9">
                  <c:v>102.2261</c:v>
                </c:pt>
                <c:pt idx="10">
                  <c:v>120.6956</c:v>
                </c:pt>
                <c:pt idx="11">
                  <c:v>89.131799999999998</c:v>
                </c:pt>
                <c:pt idx="12">
                  <c:v>60.863400000000013</c:v>
                </c:pt>
                <c:pt idx="13">
                  <c:v>12.422700000000001</c:v>
                </c:pt>
                <c:pt idx="14">
                  <c:v>9.0927000000000007</c:v>
                </c:pt>
                <c:pt idx="15">
                  <c:v>20.651499999999999</c:v>
                </c:pt>
                <c:pt idx="16">
                  <c:v>5.4755000000000003</c:v>
                </c:pt>
                <c:pt idx="17">
                  <c:v>2.8387999999999991</c:v>
                </c:pt>
                <c:pt idx="18">
                  <c:v>4.5647999999999964</c:v>
                </c:pt>
                <c:pt idx="19">
                  <c:v>9.9513000000000016</c:v>
                </c:pt>
              </c:numCache>
            </c:numRef>
          </c:val>
        </c:ser>
        <c:ser>
          <c:idx val="1"/>
          <c:order val="1"/>
          <c:tx>
            <c:strRef>
              <c:f>Blood_fed_female_ovaries_rep1!$D$1</c:f>
              <c:strCache>
                <c:ptCount val="1"/>
                <c:pt idx="0">
                  <c:v>Without miRs</c:v>
                </c:pt>
              </c:strCache>
            </c:strRef>
          </c:tx>
          <c:invertIfNegative val="0"/>
          <c:cat>
            <c:numRef>
              <c:f>Blood_fed_female_ovaries_rep1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Blood_fed_female_ovaries_rep1!$F$11:$F$30</c:f>
              <c:numCache>
                <c:formatCode>0</c:formatCode>
                <c:ptCount val="20"/>
                <c:pt idx="0">
                  <c:v>0.36230000000000001</c:v>
                </c:pt>
                <c:pt idx="1">
                  <c:v>1.6272</c:v>
                </c:pt>
                <c:pt idx="2">
                  <c:v>0.52690000000000003</c:v>
                </c:pt>
                <c:pt idx="3">
                  <c:v>0.8629</c:v>
                </c:pt>
                <c:pt idx="4">
                  <c:v>1.9131</c:v>
                </c:pt>
                <c:pt idx="5">
                  <c:v>2.5415000000000001</c:v>
                </c:pt>
                <c:pt idx="6">
                  <c:v>3.819399999999999</c:v>
                </c:pt>
                <c:pt idx="7">
                  <c:v>12.075900000000001</c:v>
                </c:pt>
                <c:pt idx="8">
                  <c:v>48.941800000000001</c:v>
                </c:pt>
                <c:pt idx="9">
                  <c:v>102.1807</c:v>
                </c:pt>
                <c:pt idx="10">
                  <c:v>120.6639</c:v>
                </c:pt>
                <c:pt idx="11">
                  <c:v>89.104900000000001</c:v>
                </c:pt>
                <c:pt idx="12">
                  <c:v>60.859200000000001</c:v>
                </c:pt>
                <c:pt idx="13">
                  <c:v>12.420999999999999</c:v>
                </c:pt>
                <c:pt idx="14">
                  <c:v>9.0921000000000003</c:v>
                </c:pt>
                <c:pt idx="15">
                  <c:v>20.6509</c:v>
                </c:pt>
                <c:pt idx="16">
                  <c:v>5.4752000000000001</c:v>
                </c:pt>
                <c:pt idx="17">
                  <c:v>2.8378000000000001</c:v>
                </c:pt>
                <c:pt idx="18">
                  <c:v>4.5636000000000001</c:v>
                </c:pt>
                <c:pt idx="19">
                  <c:v>9.94910000000000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30857728"/>
        <c:axId val="230896768"/>
      </c:barChart>
      <c:catAx>
        <c:axId val="2308577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700" b="0"/>
                </a:pPr>
                <a:r>
                  <a:rPr lang="en-US" sz="700" b="0"/>
                  <a:t>Read size (nt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896768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2308967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ad number * 10000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857728"/>
        <c:crossesAt val="1"/>
        <c:crossBetween val="between"/>
        <c:majorUnit val="20"/>
      </c:valAx>
      <c:spPr>
        <a:ln>
          <a:solidFill>
            <a:schemeClr val="tx1">
              <a:lumMod val="50000"/>
              <a:lumOff val="50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13616301350878501"/>
          <c:y val="0.13694718050311699"/>
          <c:w val="0.25402362828453001"/>
          <c:h val="0.118096498374837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/>
              <a:t>Whole male larvae</a:t>
            </a:r>
          </a:p>
        </c:rich>
      </c:tx>
      <c:layout>
        <c:manualLayout>
          <c:xMode val="edge"/>
          <c:yMode val="edge"/>
          <c:x val="0.273712829919808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2663460578833399"/>
          <c:y val="0.15060422182011099"/>
          <c:w val="0.79507663521608396"/>
          <c:h val="0.646895495955215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Whole_male_larvae_rep1!$A$1</c:f>
              <c:strCache>
                <c:ptCount val="1"/>
                <c:pt idx="0">
                  <c:v>With miRs</c:v>
                </c:pt>
              </c:strCache>
            </c:strRef>
          </c:tx>
          <c:spPr>
            <a:solidFill>
              <a:srgbClr val="308D3E"/>
            </a:solidFill>
          </c:spPr>
          <c:invertIfNegative val="0"/>
          <c:cat>
            <c:numRef>
              <c:f>Whole_male_larvae_rep1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Whole_male_larvae_rep1!$C$11:$C$30</c:f>
              <c:numCache>
                <c:formatCode>0</c:formatCode>
                <c:ptCount val="20"/>
                <c:pt idx="0">
                  <c:v>23.0685</c:v>
                </c:pt>
                <c:pt idx="1">
                  <c:v>25.517499999999991</c:v>
                </c:pt>
                <c:pt idx="2">
                  <c:v>35.7423</c:v>
                </c:pt>
                <c:pt idx="3">
                  <c:v>31.723700000000001</c:v>
                </c:pt>
                <c:pt idx="4">
                  <c:v>36.985400000000013</c:v>
                </c:pt>
                <c:pt idx="5">
                  <c:v>51.244700000000002</c:v>
                </c:pt>
                <c:pt idx="6">
                  <c:v>60.320300000000003</c:v>
                </c:pt>
                <c:pt idx="7">
                  <c:v>48.028800000000011</c:v>
                </c:pt>
                <c:pt idx="8">
                  <c:v>44.828200000000002</c:v>
                </c:pt>
                <c:pt idx="9">
                  <c:v>48.123899999999999</c:v>
                </c:pt>
                <c:pt idx="10">
                  <c:v>48.915999999999997</c:v>
                </c:pt>
                <c:pt idx="11">
                  <c:v>55.280299999999997</c:v>
                </c:pt>
                <c:pt idx="12">
                  <c:v>53.378900000000002</c:v>
                </c:pt>
                <c:pt idx="13">
                  <c:v>36.2517</c:v>
                </c:pt>
                <c:pt idx="14">
                  <c:v>32.265099999999997</c:v>
                </c:pt>
                <c:pt idx="15">
                  <c:v>29.618099999999991</c:v>
                </c:pt>
                <c:pt idx="16">
                  <c:v>36.041499999999999</c:v>
                </c:pt>
                <c:pt idx="17">
                  <c:v>34.2196</c:v>
                </c:pt>
                <c:pt idx="18">
                  <c:v>21.291799999999981</c:v>
                </c:pt>
                <c:pt idx="19">
                  <c:v>20.340399999999999</c:v>
                </c:pt>
              </c:numCache>
            </c:numRef>
          </c:val>
        </c:ser>
        <c:ser>
          <c:idx val="1"/>
          <c:order val="1"/>
          <c:tx>
            <c:strRef>
              <c:f>Whole_male_larvae_rep1!$D$1</c:f>
              <c:strCache>
                <c:ptCount val="1"/>
                <c:pt idx="0">
                  <c:v>Without miRs</c:v>
                </c:pt>
              </c:strCache>
            </c:strRef>
          </c:tx>
          <c:invertIfNegative val="0"/>
          <c:cat>
            <c:numRef>
              <c:f>Whole_male_larvae_rep1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Whole_male_larvae_rep1!$F$11:$F$30</c:f>
              <c:numCache>
                <c:formatCode>0</c:formatCode>
                <c:ptCount val="20"/>
                <c:pt idx="0">
                  <c:v>23.0395</c:v>
                </c:pt>
                <c:pt idx="1">
                  <c:v>25.427900000000001</c:v>
                </c:pt>
                <c:pt idx="2">
                  <c:v>35.661099999999998</c:v>
                </c:pt>
                <c:pt idx="3">
                  <c:v>31.398299999999999</c:v>
                </c:pt>
                <c:pt idx="4">
                  <c:v>35.971699999999998</c:v>
                </c:pt>
                <c:pt idx="5">
                  <c:v>43.384599999999999</c:v>
                </c:pt>
                <c:pt idx="6">
                  <c:v>53.227600000000002</c:v>
                </c:pt>
                <c:pt idx="7">
                  <c:v>45.371099999999998</c:v>
                </c:pt>
                <c:pt idx="8">
                  <c:v>44.521700000000003</c:v>
                </c:pt>
                <c:pt idx="9">
                  <c:v>48.114800000000002</c:v>
                </c:pt>
                <c:pt idx="10">
                  <c:v>48.914099999999998</c:v>
                </c:pt>
                <c:pt idx="11">
                  <c:v>55.279800000000002</c:v>
                </c:pt>
                <c:pt idx="12">
                  <c:v>53.378300000000003</c:v>
                </c:pt>
                <c:pt idx="13">
                  <c:v>36.251399999999997</c:v>
                </c:pt>
                <c:pt idx="14">
                  <c:v>32.265000000000001</c:v>
                </c:pt>
                <c:pt idx="15">
                  <c:v>29.617799999999999</c:v>
                </c:pt>
                <c:pt idx="16">
                  <c:v>36.0413</c:v>
                </c:pt>
                <c:pt idx="17">
                  <c:v>34.219099999999997</c:v>
                </c:pt>
                <c:pt idx="18">
                  <c:v>21.291599999999999</c:v>
                </c:pt>
                <c:pt idx="19">
                  <c:v>20.3394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30951168"/>
        <c:axId val="230953344"/>
      </c:barChart>
      <c:catAx>
        <c:axId val="2309511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700" b="0"/>
                </a:pPr>
                <a:r>
                  <a:rPr lang="en-US" sz="700" b="0"/>
                  <a:t>Read size (nt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953344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2309533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ad number * 10000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951168"/>
        <c:crossesAt val="1"/>
        <c:crossBetween val="between"/>
        <c:majorUnit val="10"/>
      </c:valAx>
      <c:spPr>
        <a:ln>
          <a:solidFill>
            <a:schemeClr val="tx1">
              <a:lumMod val="50000"/>
              <a:lumOff val="50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107821509748129"/>
          <c:y val="0.12963019758337399"/>
          <c:w val="0.26488996132757398"/>
          <c:h val="0.14717641554434799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 dirty="0" smtClean="0"/>
              <a:t>Whole female larvae</a:t>
            </a:r>
            <a:endParaRPr lang="en-US" sz="1000" b="0" dirty="0"/>
          </a:p>
        </c:rich>
      </c:tx>
      <c:layout>
        <c:manualLayout>
          <c:xMode val="edge"/>
          <c:yMode val="edge"/>
          <c:x val="0.30738151465003399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233025043998401"/>
          <c:y val="0.13879855526031401"/>
          <c:w val="0.74360793811886405"/>
          <c:h val="0.601385745740992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Whole_female_larvae_rep1!$A$1</c:f>
              <c:strCache>
                <c:ptCount val="1"/>
                <c:pt idx="0">
                  <c:v>With miRs</c:v>
                </c:pt>
              </c:strCache>
            </c:strRef>
          </c:tx>
          <c:spPr>
            <a:solidFill>
              <a:srgbClr val="308D3E"/>
            </a:solidFill>
          </c:spPr>
          <c:invertIfNegative val="0"/>
          <c:cat>
            <c:numRef>
              <c:f>Whole_female_larvae_rep1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Whole_female_larvae_rep1!$C$11:$C$30</c:f>
              <c:numCache>
                <c:formatCode>0</c:formatCode>
                <c:ptCount val="20"/>
                <c:pt idx="0">
                  <c:v>11.465199999999999</c:v>
                </c:pt>
                <c:pt idx="1">
                  <c:v>14.1313</c:v>
                </c:pt>
                <c:pt idx="2">
                  <c:v>19.657900000000001</c:v>
                </c:pt>
                <c:pt idx="3">
                  <c:v>20.785</c:v>
                </c:pt>
                <c:pt idx="4">
                  <c:v>23.139500000000009</c:v>
                </c:pt>
                <c:pt idx="5">
                  <c:v>32.043900000000001</c:v>
                </c:pt>
                <c:pt idx="6">
                  <c:v>42.773800000000001</c:v>
                </c:pt>
                <c:pt idx="7">
                  <c:v>38.0413</c:v>
                </c:pt>
                <c:pt idx="8">
                  <c:v>36.228200000000001</c:v>
                </c:pt>
                <c:pt idx="9">
                  <c:v>38.325499999999998</c:v>
                </c:pt>
                <c:pt idx="10">
                  <c:v>41.152200000000001</c:v>
                </c:pt>
                <c:pt idx="11">
                  <c:v>40.741900000000001</c:v>
                </c:pt>
                <c:pt idx="12">
                  <c:v>41.7425</c:v>
                </c:pt>
                <c:pt idx="13">
                  <c:v>33.8688</c:v>
                </c:pt>
                <c:pt idx="14">
                  <c:v>29.437999999999999</c:v>
                </c:pt>
                <c:pt idx="15">
                  <c:v>26.5762</c:v>
                </c:pt>
                <c:pt idx="16">
                  <c:v>32.157899999999998</c:v>
                </c:pt>
                <c:pt idx="17">
                  <c:v>30.147300000000001</c:v>
                </c:pt>
                <c:pt idx="18">
                  <c:v>20.101299999999991</c:v>
                </c:pt>
                <c:pt idx="19">
                  <c:v>19.381399999999999</c:v>
                </c:pt>
              </c:numCache>
            </c:numRef>
          </c:val>
        </c:ser>
        <c:ser>
          <c:idx val="1"/>
          <c:order val="1"/>
          <c:tx>
            <c:strRef>
              <c:f>Whole_female_larvae_rep1!$D$1</c:f>
              <c:strCache>
                <c:ptCount val="1"/>
                <c:pt idx="0">
                  <c:v>Without miRs</c:v>
                </c:pt>
              </c:strCache>
            </c:strRef>
          </c:tx>
          <c:invertIfNegative val="0"/>
          <c:cat>
            <c:numRef>
              <c:f>Whole_female_larvae_rep1!$D$11:$D$44</c:f>
              <c:numCache>
                <c:formatCode>General</c:formatCode>
                <c:ptCount val="34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  <c:pt idx="20">
                  <c:v>37</c:v>
                </c:pt>
                <c:pt idx="21">
                  <c:v>38</c:v>
                </c:pt>
                <c:pt idx="22">
                  <c:v>39</c:v>
                </c:pt>
                <c:pt idx="23">
                  <c:v>40</c:v>
                </c:pt>
                <c:pt idx="24">
                  <c:v>41</c:v>
                </c:pt>
                <c:pt idx="25">
                  <c:v>42</c:v>
                </c:pt>
                <c:pt idx="26">
                  <c:v>43</c:v>
                </c:pt>
                <c:pt idx="27">
                  <c:v>44</c:v>
                </c:pt>
                <c:pt idx="28">
                  <c:v>45</c:v>
                </c:pt>
                <c:pt idx="29">
                  <c:v>46</c:v>
                </c:pt>
                <c:pt idx="30">
                  <c:v>47</c:v>
                </c:pt>
                <c:pt idx="31">
                  <c:v>48</c:v>
                </c:pt>
                <c:pt idx="32">
                  <c:v>49</c:v>
                </c:pt>
                <c:pt idx="33">
                  <c:v>50</c:v>
                </c:pt>
              </c:numCache>
            </c:numRef>
          </c:cat>
          <c:val>
            <c:numRef>
              <c:f>Whole_female_larvae_rep1!$F$11:$F$30</c:f>
              <c:numCache>
                <c:formatCode>0</c:formatCode>
                <c:ptCount val="20"/>
                <c:pt idx="0">
                  <c:v>11.4552</c:v>
                </c:pt>
                <c:pt idx="1">
                  <c:v>14.0966</c:v>
                </c:pt>
                <c:pt idx="2">
                  <c:v>19.628</c:v>
                </c:pt>
                <c:pt idx="3">
                  <c:v>20.649699999999999</c:v>
                </c:pt>
                <c:pt idx="4">
                  <c:v>22.6814</c:v>
                </c:pt>
                <c:pt idx="5">
                  <c:v>28.270499999999981</c:v>
                </c:pt>
                <c:pt idx="6">
                  <c:v>39.121600000000001</c:v>
                </c:pt>
                <c:pt idx="7">
                  <c:v>36.2727</c:v>
                </c:pt>
                <c:pt idx="8">
                  <c:v>36.040500000000002</c:v>
                </c:pt>
                <c:pt idx="9">
                  <c:v>38.319099999999999</c:v>
                </c:pt>
                <c:pt idx="10">
                  <c:v>41.150599999999997</c:v>
                </c:pt>
                <c:pt idx="11">
                  <c:v>40.741799999999998</c:v>
                </c:pt>
                <c:pt idx="12">
                  <c:v>41.7423</c:v>
                </c:pt>
                <c:pt idx="13">
                  <c:v>33.868299999999998</c:v>
                </c:pt>
                <c:pt idx="14">
                  <c:v>29.437899999999999</c:v>
                </c:pt>
                <c:pt idx="15">
                  <c:v>26.5762</c:v>
                </c:pt>
                <c:pt idx="16">
                  <c:v>32.157699999999998</c:v>
                </c:pt>
                <c:pt idx="17">
                  <c:v>30.146899999999999</c:v>
                </c:pt>
                <c:pt idx="18">
                  <c:v>20.101199999999999</c:v>
                </c:pt>
                <c:pt idx="19">
                  <c:v>19.3805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30987264"/>
        <c:axId val="230989184"/>
      </c:barChart>
      <c:catAx>
        <c:axId val="2309872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700" b="0"/>
                </a:pPr>
                <a:r>
                  <a:rPr lang="en-US" sz="700" b="0" dirty="0" smtClean="0"/>
                  <a:t>Read size (</a:t>
                </a:r>
                <a:r>
                  <a:rPr lang="en-US" sz="700" b="0" dirty="0" err="1" smtClean="0"/>
                  <a:t>nt</a:t>
                </a:r>
                <a:r>
                  <a:rPr lang="en-US" sz="700" b="0" dirty="0" smtClean="0"/>
                  <a:t>)</a:t>
                </a:r>
                <a:endParaRPr lang="en-US" sz="700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989184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230989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 dirty="0" smtClean="0"/>
                  <a:t>Read number * 10000</a:t>
                </a:r>
                <a:endParaRPr lang="en-US" sz="700" b="0" dirty="0"/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en-US"/>
          </a:p>
        </c:txPr>
        <c:crossAx val="230987264"/>
        <c:crossesAt val="1"/>
        <c:crossBetween val="between"/>
      </c:valAx>
      <c:spPr>
        <a:ln>
          <a:solidFill>
            <a:schemeClr val="tx1">
              <a:lumMod val="50000"/>
              <a:lumOff val="50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13615880196594499"/>
          <c:y val="0.10787507970914301"/>
          <c:w val="0.229263402198084"/>
          <c:h val="0.14845632843628501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257F5A-3AFB-594C-9A5B-23BC3E10F2CF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620022-3215-B540-8CE1-5ABEDB351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929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42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266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141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111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397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243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768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822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383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661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09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ADF91-10EE-E847-92F6-CA6C3DBFE0B8}" type="datetimeFigureOut">
              <a:rPr lang="en-US" smtClean="0"/>
              <a:t>11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019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3788131"/>
              </p:ext>
            </p:extLst>
          </p:nvPr>
        </p:nvGraphicFramePr>
        <p:xfrm>
          <a:off x="507998" y="143933"/>
          <a:ext cx="2734735" cy="1735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8717721"/>
              </p:ext>
            </p:extLst>
          </p:nvPr>
        </p:nvGraphicFramePr>
        <p:xfrm>
          <a:off x="590550" y="1879600"/>
          <a:ext cx="2652183" cy="1718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2968390"/>
              </p:ext>
            </p:extLst>
          </p:nvPr>
        </p:nvGraphicFramePr>
        <p:xfrm>
          <a:off x="4715932" y="1947332"/>
          <a:ext cx="3081867" cy="1837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3805293"/>
              </p:ext>
            </p:extLst>
          </p:nvPr>
        </p:nvGraphicFramePr>
        <p:xfrm>
          <a:off x="4834467" y="245532"/>
          <a:ext cx="2895598" cy="1651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073201"/>
              </p:ext>
            </p:extLst>
          </p:nvPr>
        </p:nvGraphicFramePr>
        <p:xfrm>
          <a:off x="4910666" y="3674533"/>
          <a:ext cx="2887133" cy="17441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3505135"/>
              </p:ext>
            </p:extLst>
          </p:nvPr>
        </p:nvGraphicFramePr>
        <p:xfrm>
          <a:off x="590550" y="3784600"/>
          <a:ext cx="2745317" cy="15324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9336642"/>
              </p:ext>
            </p:extLst>
          </p:nvPr>
        </p:nvGraphicFramePr>
        <p:xfrm>
          <a:off x="507999" y="5317068"/>
          <a:ext cx="2971802" cy="16340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24117" y="140945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224116" y="1947332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4116" y="3654611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24117" y="5418666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D</a:t>
            </a:r>
            <a:endParaRPr lang="en-U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4596402" y="120524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E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595408" y="1947332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4596402" y="3630711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G</a:t>
            </a:r>
            <a:endParaRPr 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8008471" y="6488668"/>
            <a:ext cx="1135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9358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30</TotalTime>
  <Words>94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andro Castellano</dc:creator>
  <cp:lastModifiedBy>tfnolan</cp:lastModifiedBy>
  <cp:revision>32</cp:revision>
  <dcterms:created xsi:type="dcterms:W3CDTF">2014-01-30T12:03:48Z</dcterms:created>
  <dcterms:modified xsi:type="dcterms:W3CDTF">2014-11-27T14:00:49Z</dcterms:modified>
</cp:coreProperties>
</file>